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88" r:id="rId2"/>
    <p:sldId id="289" r:id="rId3"/>
    <p:sldId id="290" r:id="rId4"/>
    <p:sldId id="291" r:id="rId5"/>
    <p:sldId id="292" r:id="rId6"/>
    <p:sldId id="293" r:id="rId7"/>
    <p:sldId id="294" r:id="rId8"/>
    <p:sldId id="295" r:id="rId9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>
        <p:scale>
          <a:sx n="90" d="100"/>
          <a:sy n="90" d="100"/>
        </p:scale>
        <p:origin x="-1608" y="-46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image" Target="../media/image9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97E9406-4218-4F4F-A043-EAEAA2732B1A}" type="datetimeFigureOut">
              <a:rPr lang="en-US" smtClean="0"/>
              <a:pPr/>
              <a:t>4/16/20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933607B-FCFF-4E84-A6E0-0144BDF94F8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44739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933607B-FCFF-4E84-A6E0-0144BDF94F8B}" type="slidenum">
              <a:rPr lang="en-US" smtClean="0"/>
              <a:pPr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79588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933607B-FCFF-4E84-A6E0-0144BDF94F8B}" type="slidenum">
              <a:rPr lang="en-US" smtClean="0"/>
              <a:pPr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921622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CE38E85-84D1-45C2-9B3D-16105D885271}" type="slidenum">
              <a:rPr lang="en-US" smtClean="0"/>
              <a:pPr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467145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933607B-FCFF-4E84-A6E0-0144BDF94F8B}" type="slidenum">
              <a:rPr lang="en-US" smtClean="0"/>
              <a:pPr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401324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933607B-FCFF-4E84-A6E0-0144BDF94F8B}" type="slidenum">
              <a:rPr lang="en-US" smtClean="0"/>
              <a:pPr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8274642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933607B-FCFF-4E84-A6E0-0144BDF94F8B}" type="slidenum">
              <a:rPr lang="en-US" smtClean="0"/>
              <a:pPr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6267258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933607B-FCFF-4E84-A6E0-0144BDF94F8B}" type="slidenum">
              <a:rPr lang="en-US" smtClean="0"/>
              <a:pPr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35653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71830-89D0-4782-AD7B-39032E9EC902}" type="datetimeFigureOut">
              <a:rPr lang="en-US" smtClean="0"/>
              <a:pPr/>
              <a:t>4/16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BC585-D2C9-423D-A4C6-B412B42C38E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31070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71830-89D0-4782-AD7B-39032E9EC902}" type="datetimeFigureOut">
              <a:rPr lang="en-US" smtClean="0"/>
              <a:pPr/>
              <a:t>4/16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BC585-D2C9-423D-A4C6-B412B42C38E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87779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71830-89D0-4782-AD7B-39032E9EC902}" type="datetimeFigureOut">
              <a:rPr lang="en-US" smtClean="0"/>
              <a:pPr/>
              <a:t>4/16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BC585-D2C9-423D-A4C6-B412B42C38E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70605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71830-89D0-4782-AD7B-39032E9EC902}" type="datetimeFigureOut">
              <a:rPr lang="en-US" smtClean="0"/>
              <a:pPr/>
              <a:t>4/16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BC585-D2C9-423D-A4C6-B412B42C38E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16329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71830-89D0-4782-AD7B-39032E9EC902}" type="datetimeFigureOut">
              <a:rPr lang="en-US" smtClean="0"/>
              <a:pPr/>
              <a:t>4/16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BC585-D2C9-423D-A4C6-B412B42C38E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90683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71830-89D0-4782-AD7B-39032E9EC902}" type="datetimeFigureOut">
              <a:rPr lang="en-US" smtClean="0"/>
              <a:pPr/>
              <a:t>4/16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BC585-D2C9-423D-A4C6-B412B42C38E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78374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71830-89D0-4782-AD7B-39032E9EC902}" type="datetimeFigureOut">
              <a:rPr lang="en-US" smtClean="0"/>
              <a:pPr/>
              <a:t>4/16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BC585-D2C9-423D-A4C6-B412B42C38E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73762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71830-89D0-4782-AD7B-39032E9EC902}" type="datetimeFigureOut">
              <a:rPr lang="en-US" smtClean="0"/>
              <a:pPr/>
              <a:t>4/16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BC585-D2C9-423D-A4C6-B412B42C38E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19473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71830-89D0-4782-AD7B-39032E9EC902}" type="datetimeFigureOut">
              <a:rPr lang="en-US" smtClean="0"/>
              <a:pPr/>
              <a:t>4/16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BC585-D2C9-423D-A4C6-B412B42C38E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51683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71830-89D0-4782-AD7B-39032E9EC902}" type="datetimeFigureOut">
              <a:rPr lang="en-US" smtClean="0"/>
              <a:pPr/>
              <a:t>4/16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BC585-D2C9-423D-A4C6-B412B42C38E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89784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71830-89D0-4782-AD7B-39032E9EC902}" type="datetimeFigureOut">
              <a:rPr lang="en-US" smtClean="0"/>
              <a:pPr/>
              <a:t>4/16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BC585-D2C9-423D-A4C6-B412B42C38E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03179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071830-89D0-4782-AD7B-39032E9EC902}" type="datetimeFigureOut">
              <a:rPr lang="en-US" smtClean="0"/>
              <a:pPr/>
              <a:t>4/16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CBC585-D2C9-423D-A4C6-B412B42C38E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63746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emf"/><Relationship Id="rId3" Type="http://schemas.openxmlformats.org/officeDocument/2006/relationships/notesSlide" Target="../notesSlides/notesSlide2.xml"/><Relationship Id="rId7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10" Type="http://schemas.openxmlformats.org/officeDocument/2006/relationships/image" Target="../media/image10.emf"/><Relationship Id="rId4" Type="http://schemas.openxmlformats.org/officeDocument/2006/relationships/image" Target="../media/image11.png"/><Relationship Id="rId9" Type="http://schemas.openxmlformats.org/officeDocument/2006/relationships/oleObject" Target="../embeddings/oleObject2.bin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5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png"/><Relationship Id="rId5" Type="http://schemas.openxmlformats.org/officeDocument/2006/relationships/image" Target="../media/image18.png"/><Relationship Id="rId4" Type="http://schemas.openxmlformats.org/officeDocument/2006/relationships/image" Target="../media/image1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png"/><Relationship Id="rId5" Type="http://schemas.openxmlformats.org/officeDocument/2006/relationships/image" Target="../media/image22.png"/><Relationship Id="rId4" Type="http://schemas.openxmlformats.org/officeDocument/2006/relationships/image" Target="../media/image21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5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1" name="Straight Connector 10"/>
          <p:cNvCxnSpPr/>
          <p:nvPr/>
        </p:nvCxnSpPr>
        <p:spPr>
          <a:xfrm>
            <a:off x="2644503" y="594524"/>
            <a:ext cx="482600" cy="0"/>
          </a:xfrm>
          <a:prstGeom prst="line">
            <a:avLst/>
          </a:prstGeom>
          <a:ln w="63500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3156132" y="604330"/>
            <a:ext cx="274987" cy="0"/>
          </a:xfrm>
          <a:prstGeom prst="line">
            <a:avLst/>
          </a:prstGeom>
          <a:ln w="635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2633617" y="275192"/>
            <a:ext cx="4876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ER+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3083567" y="271562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ER-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8" name="Straight Connector 17"/>
          <p:cNvCxnSpPr/>
          <p:nvPr/>
        </p:nvCxnSpPr>
        <p:spPr>
          <a:xfrm>
            <a:off x="3513595" y="586778"/>
            <a:ext cx="974026" cy="0"/>
          </a:xfrm>
          <a:prstGeom prst="line">
            <a:avLst/>
          </a:prstGeom>
          <a:ln w="63500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/>
          <p:cNvCxnSpPr/>
          <p:nvPr/>
        </p:nvCxnSpPr>
        <p:spPr>
          <a:xfrm>
            <a:off x="4599814" y="602762"/>
            <a:ext cx="1006094" cy="0"/>
          </a:xfrm>
          <a:prstGeom prst="line">
            <a:avLst/>
          </a:prstGeom>
          <a:ln w="635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3762200" y="267446"/>
            <a:ext cx="4876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ER+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4928843" y="269994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ER-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Rectangle 23"/>
          <p:cNvSpPr/>
          <p:nvPr/>
        </p:nvSpPr>
        <p:spPr>
          <a:xfrm>
            <a:off x="2598033" y="13063"/>
            <a:ext cx="95571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 smtClean="0">
                <a:latin typeface="Arial" pitchFamily="34" charset="0"/>
                <a:cs typeface="Arial" pitchFamily="34" charset="0"/>
              </a:rPr>
              <a:t>This study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Rectangle 24"/>
          <p:cNvSpPr/>
          <p:nvPr/>
        </p:nvSpPr>
        <p:spPr>
          <a:xfrm>
            <a:off x="3664822" y="23572"/>
            <a:ext cx="193335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 err="1" smtClean="0">
                <a:latin typeface="Arial" pitchFamily="34" charset="0"/>
                <a:cs typeface="Arial" pitchFamily="34" charset="0"/>
              </a:rPr>
              <a:t>Terunuma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 et al JCI 2014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1" y="0"/>
            <a:ext cx="24427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l Figure 1</a:t>
            </a:r>
            <a:endParaRPr lang="en-US" b="1" dirty="0"/>
          </a:p>
        </p:txBody>
      </p:sp>
      <p:pic>
        <p:nvPicPr>
          <p:cNvPr id="17" name="Picture 16" descr="57Matched_Ours_75_Metabolites(Metabolon_method)_X_JCI_2014_Metabolon_TumorOnly-ZeroToERpos.jp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2614445" y="665018"/>
            <a:ext cx="5636362" cy="5857646"/>
          </a:xfrm>
          <a:prstGeom prst="rect">
            <a:avLst/>
          </a:prstGeom>
        </p:spPr>
      </p:pic>
      <p:pic>
        <p:nvPicPr>
          <p:cNvPr id="3" name="Picture 2" descr="Ours_X_JCI_2014_metabolon_TumorOnly_ZeroToERpos-63_Significant_colorbar.jp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399059" y="257424"/>
            <a:ext cx="890626" cy="61447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536184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634605828032227399.emf"/>
          <p:cNvPicPr>
            <a:picLocks noChangeAspect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195374" y="3753680"/>
            <a:ext cx="2310573" cy="144555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" name="Picture 2" descr="634605828052383907.emf"/>
          <p:cNvPicPr>
            <a:picLocks noChangeAspect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6396522" y="2725353"/>
            <a:ext cx="2310573" cy="144555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" name="Picture 3" descr="634605828110197147.emf"/>
          <p:cNvPicPr>
            <a:picLocks noChangeAspect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440426" y="3753680"/>
            <a:ext cx="2310573" cy="144555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" name="Picture 4" descr="634605828044571307.emf"/>
          <p:cNvPicPr>
            <a:picLocks noChangeAspect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6381267" y="1335396"/>
            <a:ext cx="2340343" cy="146418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" name="Picture 1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478082" y="1539199"/>
            <a:ext cx="5407181" cy="224178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7" name="Oval 6"/>
          <p:cNvSpPr/>
          <p:nvPr/>
        </p:nvSpPr>
        <p:spPr>
          <a:xfrm>
            <a:off x="627464" y="2063828"/>
            <a:ext cx="1091045" cy="242125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8" name="Straight Connector 7"/>
          <p:cNvCxnSpPr/>
          <p:nvPr/>
        </p:nvCxnSpPr>
        <p:spPr>
          <a:xfrm rot="16200000" flipV="1">
            <a:off x="902823" y="2724640"/>
            <a:ext cx="1558636" cy="737755"/>
          </a:xfrm>
          <a:prstGeom prst="line">
            <a:avLst/>
          </a:prstGeom>
          <a:ln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Oval 8"/>
          <p:cNvSpPr/>
          <p:nvPr/>
        </p:nvSpPr>
        <p:spPr>
          <a:xfrm>
            <a:off x="3678928" y="2019790"/>
            <a:ext cx="1091045" cy="301337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Oval 9"/>
          <p:cNvSpPr/>
          <p:nvPr/>
        </p:nvSpPr>
        <p:spPr>
          <a:xfrm>
            <a:off x="4333554" y="3079663"/>
            <a:ext cx="1091045" cy="301337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Oval 10"/>
          <p:cNvSpPr/>
          <p:nvPr/>
        </p:nvSpPr>
        <p:spPr>
          <a:xfrm>
            <a:off x="1133155" y="2542800"/>
            <a:ext cx="1967345" cy="360219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2" name="Straight Connector 11"/>
          <p:cNvCxnSpPr/>
          <p:nvPr/>
        </p:nvCxnSpPr>
        <p:spPr>
          <a:xfrm rot="16200000" flipV="1">
            <a:off x="2738393" y="3033067"/>
            <a:ext cx="1205664" cy="529933"/>
          </a:xfrm>
          <a:prstGeom prst="line">
            <a:avLst/>
          </a:prstGeom>
          <a:ln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>
            <a:stCxn id="3" idx="1"/>
            <a:endCxn id="10" idx="6"/>
          </p:cNvCxnSpPr>
          <p:nvPr/>
        </p:nvCxnSpPr>
        <p:spPr>
          <a:xfrm flipH="1" flipV="1">
            <a:off x="5424599" y="3230332"/>
            <a:ext cx="971923" cy="217801"/>
          </a:xfrm>
          <a:prstGeom prst="line">
            <a:avLst/>
          </a:prstGeom>
          <a:ln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>
            <a:stCxn id="5" idx="1"/>
            <a:endCxn id="9" idx="6"/>
          </p:cNvCxnSpPr>
          <p:nvPr/>
        </p:nvCxnSpPr>
        <p:spPr>
          <a:xfrm flipH="1">
            <a:off x="4769973" y="2067488"/>
            <a:ext cx="1611294" cy="102971"/>
          </a:xfrm>
          <a:prstGeom prst="line">
            <a:avLst/>
          </a:prstGeom>
          <a:ln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81267" y="4170911"/>
            <a:ext cx="2395985" cy="14982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6" name="TextBox 15"/>
          <p:cNvSpPr txBox="1"/>
          <p:nvPr/>
        </p:nvSpPr>
        <p:spPr>
          <a:xfrm>
            <a:off x="0" y="0"/>
            <a:ext cx="23193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upplemental Figure 2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32354714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1113003" y="3314739"/>
            <a:ext cx="6582980" cy="2214923"/>
            <a:chOff x="773873" y="2590799"/>
            <a:chExt cx="5471387" cy="1943483"/>
          </a:xfrm>
        </p:grpSpPr>
        <p:pic>
          <p:nvPicPr>
            <p:cNvPr id="9" name="Picture 3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48000" y="2590799"/>
              <a:ext cx="1559859" cy="16763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" name="Picture 4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24400" y="2604770"/>
              <a:ext cx="1520860" cy="16624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1" name="TextBox 10"/>
            <p:cNvSpPr txBox="1"/>
            <p:nvPr/>
          </p:nvSpPr>
          <p:spPr>
            <a:xfrm>
              <a:off x="1734123" y="4264223"/>
              <a:ext cx="4368950" cy="270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IDH1 R132                         IDH2  R140                                       IDH2 R172</a:t>
              </a:r>
              <a:endParaRPr lang="en-US" sz="1400" b="1" dirty="0"/>
            </a:p>
          </p:txBody>
        </p:sp>
        <p:pic>
          <p:nvPicPr>
            <p:cNvPr id="12" name="Picture 3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1447800" y="2667000"/>
              <a:ext cx="1537909" cy="147523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3" name="Rectangle 12"/>
            <p:cNvSpPr/>
            <p:nvPr/>
          </p:nvSpPr>
          <p:spPr>
            <a:xfrm>
              <a:off x="2057400" y="2667000"/>
              <a:ext cx="304800" cy="1524000"/>
            </a:xfrm>
            <a:prstGeom prst="rect">
              <a:avLst/>
            </a:prstGeom>
            <a:solidFill>
              <a:schemeClr val="accent1">
                <a:alpha val="0"/>
              </a:schemeClr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773873" y="3352800"/>
              <a:ext cx="745983" cy="3510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TCGA-</a:t>
              </a:r>
            </a:p>
            <a:p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B6-A1KF</a:t>
              </a:r>
              <a:endParaRPr 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838200" y="3886200"/>
              <a:ext cx="68062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HT1080</a:t>
              </a:r>
              <a:endParaRPr lang="en-US" sz="10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6" name="TextBox 15"/>
          <p:cNvSpPr txBox="1"/>
          <p:nvPr/>
        </p:nvSpPr>
        <p:spPr>
          <a:xfrm>
            <a:off x="819269" y="843022"/>
            <a:ext cx="7425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Arial" pitchFamily="34" charset="0"/>
                <a:cs typeface="Arial" pitchFamily="34" charset="0"/>
              </a:rPr>
              <a:t>A.</a:t>
            </a:r>
            <a:endParaRPr 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860926" y="2986147"/>
            <a:ext cx="5334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Arial" pitchFamily="34" charset="0"/>
                <a:cs typeface="Arial" pitchFamily="34" charset="0"/>
              </a:rPr>
              <a:t>B.</a:t>
            </a:r>
            <a:endParaRPr 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0" y="0"/>
            <a:ext cx="24193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l Figure 3</a:t>
            </a:r>
            <a:endParaRPr lang="en-US" b="1" dirty="0"/>
          </a:p>
        </p:txBody>
      </p:sp>
      <p:graphicFrame>
        <p:nvGraphicFramePr>
          <p:cNvPr id="2050" name="Object 2"/>
          <p:cNvGraphicFramePr>
            <a:graphicFrameLocks noChangeAspect="1"/>
          </p:cNvGraphicFramePr>
          <p:nvPr/>
        </p:nvGraphicFramePr>
        <p:xfrm>
          <a:off x="3829592" y="906961"/>
          <a:ext cx="2787650" cy="18732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2" name="Prism 6" r:id="rId7" imgW="3974458" imgH="2671263" progId="Prism6.Document">
                  <p:embed/>
                </p:oleObj>
              </mc:Choice>
              <mc:Fallback>
                <p:oleObj name="Prism 6" r:id="rId7" imgW="3974458" imgH="2671263" progId="Prism6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829592" y="906961"/>
                        <a:ext cx="2787650" cy="187325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52" name="Object 4"/>
          <p:cNvGraphicFramePr>
            <a:graphicFrameLocks noChangeAspect="1"/>
          </p:cNvGraphicFramePr>
          <p:nvPr/>
        </p:nvGraphicFramePr>
        <p:xfrm>
          <a:off x="1310777" y="895307"/>
          <a:ext cx="2705100" cy="1866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3" name="Prism 6" r:id="rId9" imgW="3855613" imgH="2661899" progId="Prism6.Document">
                  <p:embed/>
                </p:oleObj>
              </mc:Choice>
              <mc:Fallback>
                <p:oleObj name="Prism 6" r:id="rId9" imgW="3855613" imgH="2661899" progId="Prism6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310777" y="895307"/>
                        <a:ext cx="2705100" cy="18669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788644" y="1123995"/>
            <a:ext cx="78899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p&lt;0.00001</a:t>
            </a:r>
          </a:p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R=0.9987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4450078" y="1103811"/>
            <a:ext cx="78899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p&lt;0.00001</a:t>
            </a:r>
          </a:p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R=0.9674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721752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88309" y="1562483"/>
            <a:ext cx="3188572" cy="33371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228600" y="152400"/>
            <a:ext cx="32183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l Figure 4</a:t>
            </a:r>
            <a:endParaRPr lang="en-US" b="1" dirty="0"/>
          </a:p>
        </p:txBody>
      </p:sp>
      <p:sp>
        <p:nvSpPr>
          <p:cNvPr id="2" name="TextBox 1"/>
          <p:cNvSpPr txBox="1"/>
          <p:nvPr/>
        </p:nvSpPr>
        <p:spPr>
          <a:xfrm>
            <a:off x="1967616" y="1105045"/>
            <a:ext cx="442995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mRNA - BRCA1 and fatty acid synthesis genes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2" descr="C:\Users\Dr. Chi\Desktop\Color_Scale.tif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10854" y="3721396"/>
            <a:ext cx="486719" cy="117823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5383345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9126" y="895350"/>
            <a:ext cx="3657600" cy="283794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05325" y="896978"/>
            <a:ext cx="3600450" cy="28839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0576" y="3771395"/>
            <a:ext cx="3486150" cy="27923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3" name="Picture 5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43425" y="3767509"/>
            <a:ext cx="3562350" cy="28534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0" y="0"/>
            <a:ext cx="23976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Arial" pitchFamily="34" charset="0"/>
                <a:cs typeface="Arial" pitchFamily="34" charset="0"/>
              </a:rPr>
              <a:t>Supplemental Figure 5</a:t>
            </a:r>
            <a:endParaRPr 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2628900" y="1514475"/>
            <a:ext cx="1219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&lt;0.0001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6553200" y="1482209"/>
            <a:ext cx="1219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=0.0002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2743200" y="4425434"/>
            <a:ext cx="1219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=0.0002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6496050" y="4425434"/>
            <a:ext cx="1219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=0.0013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376589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50" name="Picture 6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90575" y="321856"/>
            <a:ext cx="3952875" cy="3067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7801" y="321856"/>
            <a:ext cx="3829050" cy="3067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1855382" y="1023603"/>
            <a:ext cx="10738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=0.0001</a:t>
            </a:r>
            <a:endParaRPr 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6240702" y="820471"/>
            <a:ext cx="1052623" cy="4062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=0.02</a:t>
            </a:r>
            <a:endParaRPr lang="en-US" dirty="0"/>
          </a:p>
        </p:txBody>
      </p:sp>
      <p:pic>
        <p:nvPicPr>
          <p:cNvPr id="6148" name="Picture 4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2861" y="3493238"/>
            <a:ext cx="3829050" cy="3067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1822826" y="4028071"/>
            <a:ext cx="1052623" cy="4062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=0.02</a:t>
            </a:r>
            <a:endParaRPr lang="en-US" dirty="0"/>
          </a:p>
        </p:txBody>
      </p:sp>
      <p:pic>
        <p:nvPicPr>
          <p:cNvPr id="6149" name="Picture 5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38158" y="3630915"/>
            <a:ext cx="3829050" cy="3067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6240702" y="4365691"/>
            <a:ext cx="10526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=0.01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0" y="0"/>
            <a:ext cx="23976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Arial" pitchFamily="34" charset="0"/>
                <a:cs typeface="Arial" pitchFamily="34" charset="0"/>
              </a:rPr>
              <a:t>Supplemental Figure 6</a:t>
            </a:r>
            <a:endParaRPr lang="en-US" sz="16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0624034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5749" y="1018677"/>
            <a:ext cx="4040126" cy="37034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93260" y="1018678"/>
            <a:ext cx="4026089" cy="36905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0" y="0"/>
            <a:ext cx="25695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Arial" pitchFamily="34" charset="0"/>
                <a:cs typeface="Arial" pitchFamily="34" charset="0"/>
              </a:rPr>
              <a:t>Supplemental Figure 7</a:t>
            </a:r>
            <a:endParaRPr lang="en-US" sz="16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859344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8600" y="584199"/>
            <a:ext cx="8590461" cy="62595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228600" y="152400"/>
            <a:ext cx="32183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l Figure 8</a:t>
            </a:r>
            <a:endParaRPr lang="en-US" b="1" dirty="0"/>
          </a:p>
        </p:txBody>
      </p:sp>
      <p:sp>
        <p:nvSpPr>
          <p:cNvPr id="7" name="TextBox 6"/>
          <p:cNvSpPr txBox="1"/>
          <p:nvPr/>
        </p:nvSpPr>
        <p:spPr>
          <a:xfrm>
            <a:off x="2781300" y="2279134"/>
            <a:ext cx="1066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=0.007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2913561" y="5498068"/>
            <a:ext cx="1066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=0.05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7175500" y="2215634"/>
            <a:ext cx="1066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=0.02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7200900" y="5504934"/>
            <a:ext cx="1066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=0.03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775224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510</TotalTime>
  <Words>81</Words>
  <Application>Microsoft Office PowerPoint</Application>
  <PresentationFormat>On-screen Show (4:3)</PresentationFormat>
  <Paragraphs>44</Paragraphs>
  <Slides>8</Slides>
  <Notes>7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0" baseType="lpstr">
      <vt:lpstr>Office Theme</vt:lpstr>
      <vt:lpstr>Prism 6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i00002</dc:creator>
  <cp:lastModifiedBy>Jeffrey R. Marks</cp:lastModifiedBy>
  <cp:revision>169</cp:revision>
  <cp:lastPrinted>2013-10-03T20:49:35Z</cp:lastPrinted>
  <dcterms:created xsi:type="dcterms:W3CDTF">2013-04-11T04:53:58Z</dcterms:created>
  <dcterms:modified xsi:type="dcterms:W3CDTF">2014-04-16T19:18:39Z</dcterms:modified>
</cp:coreProperties>
</file>